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59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C4181F-6438-42AD-BEBB-85658D022A0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D61EC35-D528-436C-8D2F-91319CEF2D5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2C3154-8F96-467A-B98C-9B2D34A807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1C82C-3DDC-4523-9378-055CBE09A6A9}" type="datetimeFigureOut">
              <a:rPr lang="en-GB" smtClean="0"/>
              <a:t>04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A8DD4A-5461-4AD9-A255-81771E9B64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9F36B2-8075-4ABE-87A2-6BCFA6DE80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B6E75-AEFB-4EA1-93ED-D4854F41F7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09744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496DCA-60F0-4481-AB46-0A55395587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C49D907-E23E-43AA-A4CE-3226FB8861C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9ACC2C-185C-4537-92DA-3B9848B408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1C82C-3DDC-4523-9378-055CBE09A6A9}" type="datetimeFigureOut">
              <a:rPr lang="en-GB" smtClean="0"/>
              <a:t>04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84390A-3C4E-4047-AEF0-0D264AE855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E787A3-18F3-48AD-A3D6-7177C49E65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B6E75-AEFB-4EA1-93ED-D4854F41F7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08781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BC852E6-C852-4FD5-827B-AB4CA4C852E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B88B57C-3784-414C-8B54-715A88D581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3BC416-9C75-4FE4-B38C-26AA62A5F0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1C82C-3DDC-4523-9378-055CBE09A6A9}" type="datetimeFigureOut">
              <a:rPr lang="en-GB" smtClean="0"/>
              <a:t>04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F183CD-F280-463C-89C2-1F3B71CD7A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10F67E-76E5-4E19-8160-74B32B5EAE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B6E75-AEFB-4EA1-93ED-D4854F41F7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23826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60DEE7-0616-49F0-94A7-3754F9158E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58BEFEF-9243-4E7F-908E-867BA7789C6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FE449D-ABF2-4752-9150-5295676EB4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1C82C-3DDC-4523-9378-055CBE09A6A9}" type="datetimeFigureOut">
              <a:rPr lang="en-GB" smtClean="0"/>
              <a:t>04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F62740-23BD-489C-95A7-DB0F9832EF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09BB1C-C381-4E13-882A-63B717F378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B6E75-AEFB-4EA1-93ED-D4854F41F7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99629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474D4E-7051-469D-8E04-B83A23938D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8F1D313-BA56-4634-95A9-67839A6090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D8DA40-2617-4609-A8C8-6207CCBA0D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1C82C-3DDC-4523-9378-055CBE09A6A9}" type="datetimeFigureOut">
              <a:rPr lang="en-GB" smtClean="0"/>
              <a:t>04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E9FB71-5B1A-421E-8DBF-106F68886B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2FDC5C-4F63-4291-AB4B-A26A3B32E9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B6E75-AEFB-4EA1-93ED-D4854F41F7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70060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FE4BB0-6D3F-4638-8BC1-FA1BCF2329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418F3B2-3DFC-408D-B912-38FB5FF10D1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EFAC7BB-EEFB-4E65-8BD2-BF884A676AB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DC31A7E-11D4-489E-9AA6-EC287A5E13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1C82C-3DDC-4523-9378-055CBE09A6A9}" type="datetimeFigureOut">
              <a:rPr lang="en-GB" smtClean="0"/>
              <a:t>04/12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5896039-43CC-48A6-9B32-37A8EB541D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010D384-8260-4D0C-9C3A-55DD2B3B34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B6E75-AEFB-4EA1-93ED-D4854F41F7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66516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ED2CDA-C116-47F4-96CA-DE02D46B82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07B0883-F3F5-48D9-B679-008B11504A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ADC624B-A56A-4127-A4B9-660EFD3D459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2FC0FE9-7F64-4237-8420-7CAE561A17B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A81AB9E-6F38-4392-BC62-BAC276C0806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17A74B5-75EC-48B5-9A90-83A7C9190D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1C82C-3DDC-4523-9378-055CBE09A6A9}" type="datetimeFigureOut">
              <a:rPr lang="en-GB" smtClean="0"/>
              <a:t>04/12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582AD30-A210-4CD4-A076-BD7FD43544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0DBC9F2-D678-479B-B612-9256CB8735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B6E75-AEFB-4EA1-93ED-D4854F41F7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0256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C5FF69-59AB-4825-83A7-C98DE84619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2C612CE-F2BE-4BF1-9FCD-4A50409646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1C82C-3DDC-4523-9378-055CBE09A6A9}" type="datetimeFigureOut">
              <a:rPr lang="en-GB" smtClean="0"/>
              <a:t>04/12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8A5B2BC-3E18-45AE-A6A6-FA80541228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A46D9DC-8D14-415A-B277-6F94A198A1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B6E75-AEFB-4EA1-93ED-D4854F41F7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689087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4EFF934-4519-4C7C-A38C-78AD64E4CC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1C82C-3DDC-4523-9378-055CBE09A6A9}" type="datetimeFigureOut">
              <a:rPr lang="en-GB" smtClean="0"/>
              <a:t>04/12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910F84A-7DFD-4503-87CA-30679721B5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FC54B9F-16A2-4195-BEA6-9E827EFA1C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B6E75-AEFB-4EA1-93ED-D4854F41F7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28673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99EAC9-9E0C-419E-B34C-647C90E8A5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9B604A1-E9BC-4772-AAAF-0AAE889A76E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A870430-BCD4-4E5B-AC7B-40B4B3C5E7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2F54700-2BFC-49BB-85A0-A72EB743D6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1C82C-3DDC-4523-9378-055CBE09A6A9}" type="datetimeFigureOut">
              <a:rPr lang="en-GB" smtClean="0"/>
              <a:t>04/12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6DDAF7C-4A5C-45C2-9A42-C988EC9A10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4F6942D-D515-4100-BC24-1A6FB164CC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B6E75-AEFB-4EA1-93ED-D4854F41F7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15407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D16C19-CB84-42FB-9676-17AC8542E0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C94D56D-9AE8-4ED0-A436-18FB2093CD1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9BBF8B3-9F52-46E6-AE6A-F50C754C608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318CE7E-3AD4-46E3-B29E-60B1B76EAC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1C82C-3DDC-4523-9378-055CBE09A6A9}" type="datetimeFigureOut">
              <a:rPr lang="en-GB" smtClean="0"/>
              <a:t>04/12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9D1B5F6-9A40-4E51-B97C-D8443D8288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F2A4DD3-5D02-44BA-AF9A-F1A387A20D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B6E75-AEFB-4EA1-93ED-D4854F41F7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52470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D985AD1-7D36-47D8-A2A3-43BA4F2F5C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598C325-1362-48AE-B8ED-4D14FFAD90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E9D7DF-9700-460E-9454-D5F1CBAFA69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61C82C-3DDC-4523-9378-055CBE09A6A9}" type="datetimeFigureOut">
              <a:rPr lang="en-GB" smtClean="0"/>
              <a:t>04/1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F6F0FD7-F4A8-412F-911E-7A3098E0520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A3C99F-5562-4809-9689-8BC1F03C976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CB6E75-AEFB-4EA1-93ED-D4854F41F70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29124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1BFE5D45-CD9B-4EA7-A05E-6F6B9FC815C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14780" y="567266"/>
            <a:ext cx="5162440" cy="419787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7CB7705-6DFC-470E-9C0D-D5AFE08054F2}"/>
              </a:ext>
            </a:extLst>
          </p:cNvPr>
          <p:cNvSpPr txBox="1"/>
          <p:nvPr/>
        </p:nvSpPr>
        <p:spPr>
          <a:xfrm>
            <a:off x="1312334" y="5528733"/>
            <a:ext cx="935854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 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– Correlation between average tumour fold change and average CD8 fold change. Each dot represents a single animal study. </a:t>
            </a:r>
          </a:p>
        </p:txBody>
      </p:sp>
    </p:spTree>
    <p:extLst>
      <p:ext uri="{BB962C8B-B14F-4D97-AF65-F5344CB8AC3E}">
        <p14:creationId xmlns:p14="http://schemas.microsoft.com/office/powerpoint/2010/main" val="26852130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4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aton Jones</dc:creator>
  <cp:lastModifiedBy>Keaton Jones</cp:lastModifiedBy>
  <cp:revision>1</cp:revision>
  <dcterms:created xsi:type="dcterms:W3CDTF">2023-12-04T13:36:27Z</dcterms:created>
  <dcterms:modified xsi:type="dcterms:W3CDTF">2023-12-04T13:36:40Z</dcterms:modified>
</cp:coreProperties>
</file>